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1424" y="-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877D-38BF-4CD3-8DAB-210C11A3B635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FCB40-9F82-4885-B496-D71654E8C22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9135077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877D-38BF-4CD3-8DAB-210C11A3B635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FCB40-9F82-4885-B496-D71654E8C22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2234158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877D-38BF-4CD3-8DAB-210C11A3B635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FCB40-9F82-4885-B496-D71654E8C22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76748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877D-38BF-4CD3-8DAB-210C11A3B635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FCB40-9F82-4885-B496-D71654E8C22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067779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877D-38BF-4CD3-8DAB-210C11A3B635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FCB40-9F82-4885-B496-D71654E8C22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044666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877D-38BF-4CD3-8DAB-210C11A3B635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FCB40-9F82-4885-B496-D71654E8C22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880750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877D-38BF-4CD3-8DAB-210C11A3B635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FCB40-9F82-4885-B496-D71654E8C22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761769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877D-38BF-4CD3-8DAB-210C11A3B635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FCB40-9F82-4885-B496-D71654E8C22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748094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877D-38BF-4CD3-8DAB-210C11A3B635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FCB40-9F82-4885-B496-D71654E8C22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21653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877D-38BF-4CD3-8DAB-210C11A3B635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FCB40-9F82-4885-B496-D71654E8C22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250052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877D-38BF-4CD3-8DAB-210C11A3B635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FCB40-9F82-4885-B496-D71654E8C22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809480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8A877D-38BF-4CD3-8DAB-210C11A3B635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5FCB40-9F82-4885-B496-D71654E8C22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08448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881062" y="1426527"/>
            <a:ext cx="7381875" cy="4004945"/>
          </a:xfrm>
          <a:prstGeom prst="rect">
            <a:avLst/>
          </a:prstGeom>
          <a:noFill/>
        </p:spPr>
      </p:pic>
      <p:sp>
        <p:nvSpPr>
          <p:cNvPr id="5" name="Rectangle 4"/>
          <p:cNvSpPr/>
          <p:nvPr/>
        </p:nvSpPr>
        <p:spPr>
          <a:xfrm>
            <a:off x="581024" y="5701010"/>
            <a:ext cx="813435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 smtClean="0"/>
              <a:t>Supplementary </a:t>
            </a:r>
            <a:r>
              <a:rPr lang="en-GB" dirty="0" smtClean="0"/>
              <a:t>Figure </a:t>
            </a:r>
            <a:r>
              <a:rPr lang="en-GB" dirty="0"/>
              <a:t>1: PRISMA flow diagram of trial identification, screening, eligibility and inclusion</a:t>
            </a:r>
          </a:p>
        </p:txBody>
      </p:sp>
    </p:spTree>
    <p:extLst>
      <p:ext uri="{BB962C8B-B14F-4D97-AF65-F5344CB8AC3E}">
        <p14:creationId xmlns:p14="http://schemas.microsoft.com/office/powerpoint/2010/main" xmlns="" val="1167128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6</TotalTime>
  <Words>1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R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Fisher</dc:creator>
  <cp:lastModifiedBy>LH</cp:lastModifiedBy>
  <cp:revision>58</cp:revision>
  <dcterms:created xsi:type="dcterms:W3CDTF">2018-09-12T15:41:03Z</dcterms:created>
  <dcterms:modified xsi:type="dcterms:W3CDTF">2019-01-31T07:52:47Z</dcterms:modified>
</cp:coreProperties>
</file>